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37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915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0709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021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7547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8995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6508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4810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586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7572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9769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0974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1BA23-2228-4037-B91D-E5708AE9A9D5}" type="datetimeFigureOut">
              <a:rPr lang="ko-KR" altLang="en-US" smtClean="0"/>
              <a:t>2021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5482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Figure 4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645" t="29868" r="55102" b="64492"/>
          <a:stretch/>
        </p:blipFill>
        <p:spPr>
          <a:xfrm>
            <a:off x="634540" y="3578535"/>
            <a:ext cx="1521229" cy="28567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048" t="28564" r="50931" b="48977"/>
          <a:stretch/>
        </p:blipFill>
        <p:spPr>
          <a:xfrm>
            <a:off x="634540" y="2589295"/>
            <a:ext cx="1521229" cy="94765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17" t="36820" r="59402" b="42304"/>
          <a:stretch/>
        </p:blipFill>
        <p:spPr>
          <a:xfrm>
            <a:off x="2546468" y="2589295"/>
            <a:ext cx="1512916" cy="94765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2164218" y="2590056"/>
            <a:ext cx="438005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7"/>
          <a:srcRect l="4865" t="24589" r="8968" b="30787"/>
          <a:stretch/>
        </p:blipFill>
        <p:spPr>
          <a:xfrm>
            <a:off x="2546468" y="3571744"/>
            <a:ext cx="1512916" cy="29925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4037272" y="2883971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37272" y="3579974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>
            <a:off x="635382" y="2407599"/>
            <a:ext cx="151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/>
          <p:cNvCxnSpPr/>
          <p:nvPr/>
        </p:nvCxnSpPr>
        <p:spPr>
          <a:xfrm>
            <a:off x="2532860" y="2407599"/>
            <a:ext cx="151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40099" y="2170414"/>
            <a:ext cx="1300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PTEpi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 (Fetal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642139" y="2170414"/>
            <a:ext cx="13260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PTEpi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 (Adult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43821" y="2379279"/>
            <a:ext cx="39356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      0.2      1       5       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10       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0      0.2      1       5       10  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g/ml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직선 연결선 14"/>
          <p:cNvCxnSpPr/>
          <p:nvPr/>
        </p:nvCxnSpPr>
        <p:spPr>
          <a:xfrm>
            <a:off x="634540" y="2164075"/>
            <a:ext cx="34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967081" y="1926898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 / 24hr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65191" y="2386879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165970" y="2425556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5048" y="1820333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001" t="25544" r="8043" b="61084"/>
          <a:stretch/>
        </p:blipFill>
        <p:spPr>
          <a:xfrm>
            <a:off x="6443134" y="2472865"/>
            <a:ext cx="3462866" cy="480954"/>
          </a:xfrm>
          <a:prstGeom prst="rect">
            <a:avLst/>
          </a:prstGeom>
          <a:ln w="3175">
            <a:noFill/>
          </a:ln>
        </p:spPr>
      </p:pic>
      <p:pic>
        <p:nvPicPr>
          <p:cNvPr id="21" name="그림 20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053" t="14741" r="578" b="42719"/>
          <a:stretch/>
        </p:blipFill>
        <p:spPr>
          <a:xfrm>
            <a:off x="6443134" y="630623"/>
            <a:ext cx="3430238" cy="1296275"/>
          </a:xfrm>
          <a:prstGeom prst="rect">
            <a:avLst/>
          </a:prstGeom>
          <a:ln w="3175">
            <a:noFill/>
          </a:ln>
        </p:spPr>
      </p:pic>
      <p:sp>
        <p:nvSpPr>
          <p:cNvPr id="22" name="오른쪽 대괄호 21"/>
          <p:cNvSpPr/>
          <p:nvPr/>
        </p:nvSpPr>
        <p:spPr>
          <a:xfrm rot="16200000">
            <a:off x="7215837" y="164729"/>
            <a:ext cx="266008" cy="931785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6584850" y="83910"/>
            <a:ext cx="15279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RL-2)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PTEpi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 (Fetal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오른쪽 대괄호 23"/>
          <p:cNvSpPr/>
          <p:nvPr/>
        </p:nvSpPr>
        <p:spPr>
          <a:xfrm rot="16200000">
            <a:off x="7214956" y="1979462"/>
            <a:ext cx="266008" cy="93354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>
            <a:off x="6559451" y="1929001"/>
            <a:ext cx="15279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0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PTEpi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 (Fetal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그림 3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9" t="26770" r="9105" b="32147"/>
          <a:stretch/>
        </p:blipFill>
        <p:spPr>
          <a:xfrm>
            <a:off x="6443135" y="3689203"/>
            <a:ext cx="3430238" cy="1280604"/>
          </a:xfrm>
          <a:prstGeom prst="rect">
            <a:avLst/>
          </a:prstGeom>
          <a:ln w="3175">
            <a:noFill/>
          </a:ln>
        </p:spPr>
      </p:pic>
      <p:pic>
        <p:nvPicPr>
          <p:cNvPr id="33" name="그림 32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18" t="62695" r="14169" b="18789"/>
          <a:stretch/>
        </p:blipFill>
        <p:spPr>
          <a:xfrm>
            <a:off x="6443135" y="5895507"/>
            <a:ext cx="3430238" cy="680134"/>
          </a:xfrm>
          <a:prstGeom prst="rect">
            <a:avLst/>
          </a:prstGeom>
          <a:ln w="3175">
            <a:noFill/>
          </a:ln>
        </p:spPr>
      </p:pic>
      <p:sp>
        <p:nvSpPr>
          <p:cNvPr id="34" name="오른쪽 대괄호 33"/>
          <p:cNvSpPr/>
          <p:nvPr/>
        </p:nvSpPr>
        <p:spPr>
          <a:xfrm rot="16200000">
            <a:off x="7249649" y="3120820"/>
            <a:ext cx="266008" cy="8641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6630372" y="3024757"/>
            <a:ext cx="15584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RL-2)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PTEpi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 (Adult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오른쪽 대괄호 35"/>
          <p:cNvSpPr/>
          <p:nvPr/>
        </p:nvSpPr>
        <p:spPr>
          <a:xfrm rot="16200000">
            <a:off x="7033692" y="5408336"/>
            <a:ext cx="266008" cy="97434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/>
          <p:cNvSpPr txBox="1"/>
          <p:nvPr/>
        </p:nvSpPr>
        <p:spPr>
          <a:xfrm>
            <a:off x="6374667" y="5379186"/>
            <a:ext cx="15584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0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PTEpi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 (Adult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067524" y="556593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005194" y="3932636"/>
            <a:ext cx="4379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224413" y="2454071"/>
            <a:ext cx="438005" cy="16158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7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altLang="ko-K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061230" y="3749106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061230" y="605017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6034849" y="5900384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104073" y="2562365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077692" y="2412574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012500" y="882419"/>
            <a:ext cx="4379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6061230" y="1531410"/>
            <a:ext cx="380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7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1038534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30</Words>
  <Application>Microsoft Office PowerPoint</Application>
  <PresentationFormat>와이드스크린</PresentationFormat>
  <Paragraphs>5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ung-Kyun Park</cp:lastModifiedBy>
  <cp:revision>4</cp:revision>
  <dcterms:created xsi:type="dcterms:W3CDTF">2021-10-12T00:46:16Z</dcterms:created>
  <dcterms:modified xsi:type="dcterms:W3CDTF">2021-10-12T03:16:04Z</dcterms:modified>
</cp:coreProperties>
</file>